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CA126-1968-49F9-94E2-52E09787DA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CE9F9-30E0-4C73-BE5D-DC5375F730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2BCCB-878F-4D5D-A8FE-8150A04E81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67AA5-1586-4610-A5BC-7C1BEF7161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456AE-D226-4DF8-9326-2EEA30B473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52A1A-FF4C-473F-A073-2BC24B0FEF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0E745-DFEB-46AF-A001-1CA35E4BC1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16980-1755-4ADC-ABDD-4C17979386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66FEC-E812-4B4F-996A-9BE5038BB6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096CE-95D5-45BA-B6EB-4CF1A9D9EA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9F1C7-1F7F-4105-9952-F4EF933A9C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9A2CA-20D4-41C1-894B-1CB7A4A7C6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A9C3F6-A702-43A4-BA93-0A45819151A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"/>
          <p:cNvPicPr/>
          <p:nvPr/>
        </p:nvPicPr>
        <p:blipFill>
          <a:blip r:embed="rId1"/>
          <a:stretch/>
        </p:blipFill>
        <p:spPr>
          <a:xfrm>
            <a:off x="4716360" y="981000"/>
            <a:ext cx="3743280" cy="3708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250920" y="907920"/>
            <a:ext cx="4416480" cy="38149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539640" y="5373720"/>
            <a:ext cx="79200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rrelation between SPFH1 and -2 genes and their accompanying NfeD1 and -2 genes. Trees were generated with the nearest-neighbor algorithm (1000 bootstrap replications) using the blosum matrix and a gap separation of 4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15T14:04:44Z</dcterms:created>
  <dc:creator>Alex</dc:creator>
  <dc:description/>
  <dc:language>en-US</dc:language>
  <cp:lastModifiedBy>Alex</cp:lastModifiedBy>
  <dcterms:modified xsi:type="dcterms:W3CDTF">2008-06-15T14:09:23Z</dcterms:modified>
  <cp:revision>1</cp:revision>
  <dc:subject/>
  <dc:title>Slide 1</dc:title>
</cp:coreProperties>
</file>